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DD1CB-9DD6-410A-AF9E-A650D3521D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3FAF3-DF54-482F-9060-BB6C3CCEEA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A5799C-B69C-47FF-8213-B21AF2C8B5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411FAB-7DFE-4570-9D1B-CBB2686BC4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1DFCD-FC52-4943-9DF5-058159D32D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10F65-67B4-4CB5-9DB0-3C20469045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3B6A0-8448-4ABA-B537-7FBA1D8AD0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1924F-D200-4EFF-B412-FC573F0A6B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B9349-8369-49C0-ABD0-B8D92AB1D8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BD76A-5E9F-4C2A-8668-5615A54023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C64C7-1A88-4F2E-AE31-819A482DF7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F8B1F-8F8A-4E1A-A491-ADCC30847D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F507E4-03CB-41ED-942E-8E97A376C54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06640" y="299880"/>
          <a:ext cx="2097000" cy="5531040"/>
        </p:xfrm>
        <a:graphic>
          <a:graphicData uri="http://schemas.openxmlformats.org/drawingml/2006/table">
            <a:tbl>
              <a:tblPr/>
              <a:tblGrid>
                <a:gridCol w="1047600"/>
                <a:gridCol w="1049400"/>
              </a:tblGrid>
              <a:tr h="19224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issProt Indentifie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 Peptide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8WX92 (NELFB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H3P2 (NELFA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18615 (NELFE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8IXH7 (NELFD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9c3"/>
                    </a:solidFill>
                  </a:tcPr>
                </a:tc>
              </a:tr>
              <a:tr h="2556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00267 (SPT5H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b9b8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b9b8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2492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RPB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30876 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RPB2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19387 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RPB3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19388 (RPAB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eb4e3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8N201 (INT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56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H0H0 (INT2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6HW7 (INT4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6P9B9 (INT5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UL03 (INT6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NVH2 (INT7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75QN2 (INT8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56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NV88 (INT9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NVR2 (INT10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5TA45 (INT1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6CB8 (INT12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9NVM9 (M89BB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3654360" y="299880"/>
          <a:ext cx="2097000" cy="4938840"/>
        </p:xfrm>
        <a:graphic>
          <a:graphicData uri="http://schemas.openxmlformats.org/drawingml/2006/table">
            <a:tbl>
              <a:tblPr/>
              <a:tblGrid>
                <a:gridCol w="1047960"/>
                <a:gridCol w="1049040"/>
              </a:tblGrid>
              <a:tr h="19224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issProt Indentifie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 Peptide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11142 (HSP7C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11021 (GRP78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08107 (HSP7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34931 (HS71L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56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78347 (GTF2I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09161 (NCBP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67775 (PP2AA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8N532 (Q8N532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71UI9 (H2AV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48741 (HSP77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56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00839 (HNRPU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4DFN9 (B4DFN9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43143 (DHX15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08107 (HSP7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11142 (HSP7C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16992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35637 (FUS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416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68366 (TBA4A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38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2T9F4 (IN4L2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55600">
                <a:tc>
                  <a:txBody>
                    <a:bodyPr lIns="95040" rIns="95040" tIns="42480" bIns="424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06830 (PRDX1_HUMAN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5040" rIns="95040" tIns="42480" bIns="4248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5040" marR="95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  <p:sp>
        <p:nvSpPr>
          <p:cNvPr id="43" name="Rectangle 3"/>
          <p:cNvSpPr/>
          <p:nvPr/>
        </p:nvSpPr>
        <p:spPr>
          <a:xfrm>
            <a:off x="4683240" y="5491080"/>
            <a:ext cx="149040" cy="66600"/>
          </a:xfrm>
          <a:prstGeom prst="rect">
            <a:avLst/>
          </a:prstGeom>
          <a:solidFill>
            <a:srgbClr val="f2f2f2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4"/>
          <p:cNvSpPr/>
          <p:nvPr/>
        </p:nvSpPr>
        <p:spPr>
          <a:xfrm>
            <a:off x="3643200" y="5491080"/>
            <a:ext cx="150840" cy="66600"/>
          </a:xfrm>
          <a:prstGeom prst="rect">
            <a:avLst/>
          </a:prstGeom>
          <a:solidFill>
            <a:srgbClr val="e6b9b8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3643200" y="5630760"/>
            <a:ext cx="150840" cy="66600"/>
          </a:xfrm>
          <a:prstGeom prst="rect">
            <a:avLst/>
          </a:prstGeom>
          <a:solidFill>
            <a:srgbClr val="8eb4e3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3643200" y="5357880"/>
            <a:ext cx="150840" cy="66600"/>
          </a:xfrm>
          <a:prstGeom prst="rect">
            <a:avLst/>
          </a:prstGeom>
          <a:solidFill>
            <a:srgbClr val="ddd9c3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8"/>
          <p:cNvSpPr/>
          <p:nvPr/>
        </p:nvSpPr>
        <p:spPr>
          <a:xfrm>
            <a:off x="3728880" y="5305320"/>
            <a:ext cx="824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LF Comple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9"/>
          <p:cNvSpPr/>
          <p:nvPr/>
        </p:nvSpPr>
        <p:spPr>
          <a:xfrm>
            <a:off x="3738600" y="5438880"/>
            <a:ext cx="50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IF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10"/>
          <p:cNvSpPr/>
          <p:nvPr/>
        </p:nvSpPr>
        <p:spPr>
          <a:xfrm>
            <a:off x="3738600" y="5580000"/>
            <a:ext cx="879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NAPII Comple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4683240" y="5357880"/>
            <a:ext cx="149040" cy="66600"/>
          </a:xfrm>
          <a:prstGeom prst="rect">
            <a:avLst/>
          </a:prstGeom>
          <a:solidFill>
            <a:srgbClr val="7f7f7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14"/>
          <p:cNvSpPr/>
          <p:nvPr/>
        </p:nvSpPr>
        <p:spPr>
          <a:xfrm>
            <a:off x="4778280" y="5305320"/>
            <a:ext cx="1179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grator Comple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15"/>
          <p:cNvSpPr/>
          <p:nvPr/>
        </p:nvSpPr>
        <p:spPr>
          <a:xfrm>
            <a:off x="4788000" y="5451480"/>
            <a:ext cx="1393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-categorized protei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ZoneTexte 16"/>
          <p:cNvSpPr/>
          <p:nvPr/>
        </p:nvSpPr>
        <p:spPr>
          <a:xfrm>
            <a:off x="131760" y="4680"/>
            <a:ext cx="19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. S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12T09:03:01Z</dcterms:created>
  <dc:creator>Monsef Benkirane</dc:creator>
  <dc:description/>
  <dc:language>en-US</dc:language>
  <cp:lastModifiedBy>Monsef Benkirane</cp:lastModifiedBy>
  <dcterms:modified xsi:type="dcterms:W3CDTF">2014-07-12T09:04:26Z</dcterms:modified>
  <cp:revision>1</cp:revision>
  <dc:subject/>
  <dc:title>PowerPoint Presentation</dc:title>
</cp:coreProperties>
</file>